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3"/>
  </p:notesMasterIdLst>
  <p:sldIdLst>
    <p:sldId id="298" r:id="rId2"/>
    <p:sldId id="297" r:id="rId3"/>
    <p:sldId id="278" r:id="rId4"/>
    <p:sldId id="289" r:id="rId5"/>
    <p:sldId id="290" r:id="rId6"/>
    <p:sldId id="291" r:id="rId7"/>
    <p:sldId id="292" r:id="rId8"/>
    <p:sldId id="293" r:id="rId9"/>
    <p:sldId id="294" r:id="rId10"/>
    <p:sldId id="295" r:id="rId11"/>
    <p:sldId id="296" r:id="rId12"/>
    <p:sldId id="288" r:id="rId13"/>
    <p:sldId id="279" r:id="rId14"/>
    <p:sldId id="280" r:id="rId15"/>
    <p:sldId id="281" r:id="rId16"/>
    <p:sldId id="282" r:id="rId17"/>
    <p:sldId id="283" r:id="rId18"/>
    <p:sldId id="284" r:id="rId19"/>
    <p:sldId id="285" r:id="rId20"/>
    <p:sldId id="286" r:id="rId21"/>
    <p:sldId id="287" r:id="rId2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1279" autoAdjust="0"/>
  </p:normalViewPr>
  <p:slideViewPr>
    <p:cSldViewPr snapToGrid="0">
      <p:cViewPr>
        <p:scale>
          <a:sx n="100" d="100"/>
          <a:sy n="100" d="100"/>
        </p:scale>
        <p:origin x="91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E1EF13-9A35-4195-BBE3-DFBC06633543}" type="datetimeFigureOut">
              <a:rPr lang="it-IT" smtClean="0"/>
              <a:t>10/02/2023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CAAC06-9EDF-4A77-BAA8-B06F355A22E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78404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arval locomotion data at 5 dpf. A-C: average distance moved by controls, SHMO and SBMO groups, respectively. D-F: average velocity of controls, SHMO and SBMO groups, respectively. Values are expressed as means (n=72 per group).</a:t>
            </a:r>
            <a:r>
              <a:rPr lang="en-GB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****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≤ 0.0001. The error bars show the standard error of the mean. Abbreviation: SHMO: sialylated human milk oligosaccharide treatment; SBMO: sialylated bovine milk oligosaccharide treatment. </a:t>
            </a:r>
            <a:endParaRPr lang="it-IT" dirty="0" smtClean="0">
              <a:effectLst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0388837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10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HMO injection in zebrafish larvae –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ioxidant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ction of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itamin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10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3799848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11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HMO injection in zebrafish larvae – 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G2 Signaling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thway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1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8374677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12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BMO injection in zebrafish larvae – 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XR/RXR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ctivatio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1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7039132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13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BMO injection in zebrafish larvae –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utamate</a:t>
            </a:r>
            <a:r>
              <a:rPr lang="it-IT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it-IT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ceptor</a:t>
            </a:r>
            <a:r>
              <a:rPr lang="it-IT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gnaling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1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3247477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14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BMO injection in zebrafish larvae –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ynaptogenesis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gnaling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thway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1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7861334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15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BMO injection in zebrafish larvae –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docannabinoid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euronal</a:t>
            </a:r>
            <a:r>
              <a:rPr lang="it-IT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it-IT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ynapse</a:t>
            </a:r>
            <a:r>
              <a:rPr lang="it-IT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it-IT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hway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15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7307785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16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BMO injection in zebrafish larvae –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lcium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gnaling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16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68343681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17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BMO injection in zebrafish larvae –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Xenobiotic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tabolism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HR Signaling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thway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17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8383070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18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BMO injection in zebrafish larvae –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tioxidant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ctio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18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59670002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19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BMO injection in zebrafish larvae – 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P6 Signaling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thway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19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882304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.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igmotaxis data at 5 dpf presented as time spent (s) in the outer zone of the test apparatus. </a:t>
            </a: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average thigmotaxis of controls; </a:t>
            </a: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average thigmotaxis of SHMO group; </a:t>
            </a: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average thigmotaxis of SBMO group. Values are expressed as means (n=72 per group).</a:t>
            </a:r>
            <a:r>
              <a:rPr lang="en-GB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***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≤ 0.001; </a:t>
            </a:r>
            <a:r>
              <a:rPr lang="en-GB" sz="120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***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≤ 0.0001. The error bars show the standard error of the mean. Abbreviation: SHMO: sialylated human milk oligosaccharide treatment; SBMO: sialylated bovine milk oligosaccharide treatment. </a:t>
            </a:r>
            <a:endParaRPr lang="it-IT" dirty="0" smtClean="0">
              <a:effectLst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4654731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20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BMO injection in zebrafish larvae – 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duction of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itric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xide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ROS in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crophages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20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0158465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21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BMO injection in zebrafish larvae –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Xenobiotic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tabolism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XR Signaling </a:t>
            </a:r>
            <a:r>
              <a:rPr lang="it-IT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thway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2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217819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b="1" dirty="0" smtClean="0"/>
              <a:t>Figure S3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HMO injection in zebrafish larvae – Cell Cycle Control of Chromosomal Replicatio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3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663810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4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HMO injection in zebrafish larvae – LXR/RXR Activatio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4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982554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5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HMO injection in zebrafish larvae –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erropoptosi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gnaling Pathway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5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85518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6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HMO injection in zebrafish larvae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– A):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erpathway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Cholesterol Biosynthesis; B): Heme degradation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6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1337599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7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HMO injection in zebrafish larvae – Unfolded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rotein Response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7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058729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8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HMO injection in zebrafish larvae –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utation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dox Reaction I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8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289594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/>
              <a:t>Figure S9</a:t>
            </a:r>
            <a:r>
              <a:rPr lang="it-IT" dirty="0" smtClean="0"/>
              <a:t>.</a:t>
            </a:r>
            <a:r>
              <a:rPr lang="it-IT" baseline="0" dirty="0" smtClean="0"/>
              <a:t> </a:t>
            </a:r>
            <a:r>
              <a:rPr lang="it-IT" baseline="0" dirty="0" err="1" smtClean="0"/>
              <a:t>Expression</a:t>
            </a:r>
            <a:r>
              <a:rPr lang="it-IT" baseline="0" dirty="0" smtClean="0"/>
              <a:t> of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in SHMO injection in zebrafish larvae – HIF1</a:t>
            </a:r>
            <a:r>
              <a:rPr lang="el-G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α</a:t>
            </a:r>
            <a:r>
              <a:rPr lang="it-IT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gnaling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Gs ar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ur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blue if downregulated and red if upregulated.</a:t>
            </a:r>
            <a:endParaRPr lang="it-IT" baseline="0" dirty="0" smtClean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CAAC06-9EDF-4A77-BAA8-B06F355A22E6}" type="slidenum">
              <a:rPr lang="it-IT" smtClean="0"/>
              <a:t>9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795163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1DE9ACA-FB91-496C-9887-B5F17E985C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7BEECC0F-E1F3-4396-A982-E4F006009B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2063706-7E6F-477D-8074-E5C57BC21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76C8F-88DD-4FA9-B18D-8068AD41D960}" type="datetimeFigureOut">
              <a:rPr lang="it-IT" smtClean="0"/>
              <a:t>10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A48ABC3-6F45-49E8-A363-C94C7118D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A8DBA40-6AE1-45B9-A2FF-C41EF3FAF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7DDD3F-85CA-43C0-97B6-A39B81329B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8753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74449FE-58B1-4278-9487-8DC2D06D77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F1B7AF1-AAEE-41FF-8C31-9ED7DBFB50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7DD49E3-B4CF-4E88-9442-45B75E81D2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76C8F-88DD-4FA9-B18D-8068AD41D960}" type="datetimeFigureOut">
              <a:rPr lang="it-IT" smtClean="0"/>
              <a:t>10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541B2A5-4663-412A-825C-C65396B29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AB42AE7-B1F3-4B3E-8E51-4C47828D0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7DDD3F-85CA-43C0-97B6-A39B81329B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9296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EF080BA9-E2B9-4BBB-AC26-F226CFBD58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9866BDB-465B-4AA8-8985-125094ACFA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3AA7E28-40DE-4DCA-8623-5B79566B2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76C8F-88DD-4FA9-B18D-8068AD41D960}" type="datetimeFigureOut">
              <a:rPr lang="it-IT" smtClean="0"/>
              <a:t>10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7D8086E-04EE-407C-9A21-F5244D711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073C855-8151-444D-925E-0B870C380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7DDD3F-85CA-43C0-97B6-A39B81329B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2151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7174277-FF27-42EB-8453-A0130CC5D0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4B05047-C6A0-4884-8ECC-07334C0D57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DC72E33-50BB-421C-8EF1-2460F70E0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76C8F-88DD-4FA9-B18D-8068AD41D960}" type="datetimeFigureOut">
              <a:rPr lang="it-IT" smtClean="0"/>
              <a:t>10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9CCF184-0A90-4787-B31F-E717F1318C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F0373CE-3E73-4E16-AB5D-9BD41B32F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7DDD3F-85CA-43C0-97B6-A39B81329B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4787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07FC1B5-EC0D-4661-B0D3-9A8CA597DF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A95A4D1-27A3-4BF4-B374-D47E595F0C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A04EFC3-C1FF-482F-955D-7B07256B3C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76C8F-88DD-4FA9-B18D-8068AD41D960}" type="datetimeFigureOut">
              <a:rPr lang="it-IT" smtClean="0"/>
              <a:t>10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21C54DE-E0B1-4020-82FF-AA47B0B84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1B56AD8-6A11-48E6-AD8C-F8C525A63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7DDD3F-85CA-43C0-97B6-A39B81329B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3256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184CCCF-48B1-45AF-BC01-8FC3220EC2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B264B5C-6AF0-4CDD-9A91-165C80D2DF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17E33E6-19EE-4A3D-ACF4-9ABD2F1702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042AC1D-7FB9-4E1B-A858-64C91E602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76C8F-88DD-4FA9-B18D-8068AD41D960}" type="datetimeFigureOut">
              <a:rPr lang="it-IT" smtClean="0"/>
              <a:t>10/02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5DB75FA-E8A5-4C16-9F8D-7CFA1A737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B608444-7D6D-409E-B380-DAF8BACA3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7DDD3F-85CA-43C0-97B6-A39B81329B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66184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17E3D8F-8F06-4B63-97E8-6C9203EBA9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8AF1442-2C2E-4C09-90A9-3FECF1111A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BBC754E-FC4A-4B9C-B1DC-FCABB6F009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B032675-D48B-44F0-B280-B127563490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B039FE5-694C-414C-98B6-F9E1A4E29C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91753CA-A270-4D5B-9BA8-8A3FB2AE1B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76C8F-88DD-4FA9-B18D-8068AD41D960}" type="datetimeFigureOut">
              <a:rPr lang="it-IT" smtClean="0"/>
              <a:t>10/02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65130DBF-22EA-48CB-B02A-846C7AEB0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9C81B089-08C7-468C-B66D-4CC71BDCF6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7DDD3F-85CA-43C0-97B6-A39B81329B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8131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D95D294-3B56-4424-86B6-1FA0A88E5E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B6A4E4F-491C-4B08-97D6-C7159E45D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76C8F-88DD-4FA9-B18D-8068AD41D960}" type="datetimeFigureOut">
              <a:rPr lang="it-IT" smtClean="0"/>
              <a:t>10/02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18894C7-3144-4E2D-AE43-64F04038F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3E5D029-6365-40BA-8214-7F6139D9B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7DDD3F-85CA-43C0-97B6-A39B81329B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69349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CA3DF5A-FCDA-4016-8AD9-FE5AE2CCEF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76C8F-88DD-4FA9-B18D-8068AD41D960}" type="datetimeFigureOut">
              <a:rPr lang="it-IT" smtClean="0"/>
              <a:t>10/02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588CDBE5-771D-4CE4-8189-F2252B326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A89C90CB-9366-4907-8A63-DE5B2AFAAA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7DDD3F-85CA-43C0-97B6-A39B81329B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7866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DAE14A0-2202-400E-9849-F08CBCC2EA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C266F18-740A-4189-A282-FF7D41B2AE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5F84B3F-3550-4A00-8BDC-3D549C4E15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A2DEE34-02CC-4A5F-884F-661B47019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76C8F-88DD-4FA9-B18D-8068AD41D960}" type="datetimeFigureOut">
              <a:rPr lang="it-IT" smtClean="0"/>
              <a:t>10/02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A1A6D75-1DE4-42D8-8EB2-3943F053C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8B3DA52-7692-4354-8A55-120E8D1D6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7DDD3F-85CA-43C0-97B6-A39B81329B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5496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E83E41A-8F64-4E3C-AA22-3FBDEDB151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25FF45C-B6CE-4284-B8FC-DC06448973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8F15ACC-051D-4EAC-8DC5-48D6165CDC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D023B04-49CF-4E3D-B981-5778D5C4CC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176C8F-88DD-4FA9-B18D-8068AD41D960}" type="datetimeFigureOut">
              <a:rPr lang="it-IT" smtClean="0"/>
              <a:t>10/02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D4E2C94-1256-4EB3-A8AA-F74781D51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224017C-74AD-48F3-A7A4-42D1F030E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7DDD3F-85CA-43C0-97B6-A39B81329B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7767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A39F598E-607E-4E93-80A6-C2556FB7A5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B55A65D-496B-470E-8448-9323CC8818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A22B619-BB78-4164-A6E5-76276BFA38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176C8F-88DD-4FA9-B18D-8068AD41D960}" type="datetimeFigureOut">
              <a:rPr lang="it-IT" smtClean="0"/>
              <a:t>10/02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CFDC0B1-730C-45AF-A9F4-48B3C60486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EB8168A-D989-47BB-A92B-41F8E816A8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7DDD3F-85CA-43C0-97B6-A39B81329B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5134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5769" y="1186033"/>
            <a:ext cx="10509127" cy="42987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66350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62925" y="368515"/>
            <a:ext cx="766615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24058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62925" y="345655"/>
            <a:ext cx="766615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44768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690" y="380312"/>
            <a:ext cx="1178662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72678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3074" y="417642"/>
            <a:ext cx="11466802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5719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165" y="367362"/>
            <a:ext cx="1178662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49737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202690" y="556856"/>
            <a:ext cx="11786620" cy="5780055"/>
            <a:chOff x="202690" y="756881"/>
            <a:chExt cx="11786620" cy="5780055"/>
          </a:xfrm>
        </p:grpSpPr>
        <p:pic>
          <p:nvPicPr>
            <p:cNvPr id="3" name="Immagine 2"/>
            <p:cNvPicPr>
              <a:picLocks noChangeAspect="1"/>
            </p:cNvPicPr>
            <p:nvPr/>
          </p:nvPicPr>
          <p:blipFill rotWithShape="1">
            <a:blip r:embed="rId3"/>
            <a:srcRect t="7478"/>
            <a:stretch/>
          </p:blipFill>
          <p:spPr>
            <a:xfrm>
              <a:off x="202690" y="1207697"/>
              <a:ext cx="11786620" cy="5329239"/>
            </a:xfrm>
            <a:prstGeom prst="rect">
              <a:avLst/>
            </a:prstGeom>
          </p:spPr>
        </p:pic>
        <p:sp>
          <p:nvSpPr>
            <p:cNvPr id="2" name="Rettangolo 1"/>
            <p:cNvSpPr/>
            <p:nvPr/>
          </p:nvSpPr>
          <p:spPr>
            <a:xfrm>
              <a:off x="3484387" y="756881"/>
              <a:ext cx="5223225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sz="1400" b="1" dirty="0" smtClean="0">
                  <a:cs typeface="Calibri" panose="020F0502020204030204" pitchFamily="34" charset="0"/>
                </a:rPr>
                <a:t>SBMO </a:t>
              </a:r>
              <a:r>
                <a:rPr lang="it-IT" sz="1400" b="1" dirty="0" err="1" smtClean="0">
                  <a:cs typeface="Calibri" panose="020F0502020204030204" pitchFamily="34" charset="0"/>
                </a:rPr>
                <a:t>treated</a:t>
              </a:r>
              <a:r>
                <a:rPr lang="it-IT" sz="1400" b="1" dirty="0" smtClean="0">
                  <a:cs typeface="Calibri" panose="020F0502020204030204" pitchFamily="34" charset="0"/>
                </a:rPr>
                <a:t> </a:t>
              </a:r>
              <a:r>
                <a:rPr lang="it-IT" sz="1400" b="1" dirty="0" err="1" smtClean="0">
                  <a:cs typeface="Calibri" panose="020F0502020204030204" pitchFamily="34" charset="0"/>
                </a:rPr>
                <a:t>larvae</a:t>
              </a:r>
              <a:r>
                <a:rPr lang="it-IT" sz="1400" b="1" dirty="0" smtClean="0">
                  <a:cs typeface="Calibri" panose="020F0502020204030204" pitchFamily="34" charset="0"/>
                </a:rPr>
                <a:t> - </a:t>
              </a:r>
              <a:r>
                <a:rPr lang="it-IT" sz="1400" b="1" dirty="0" err="1" smtClean="0">
                  <a:cs typeface="Calibri" panose="020F0502020204030204" pitchFamily="34" charset="0"/>
                </a:rPr>
                <a:t>Endocannabinoid</a:t>
              </a:r>
              <a:r>
                <a:rPr lang="it-IT" sz="1400" b="1" dirty="0" smtClean="0">
                  <a:cs typeface="Arial" panose="020B0604020202020204" pitchFamily="34" charset="0"/>
                </a:rPr>
                <a:t> </a:t>
              </a:r>
              <a:r>
                <a:rPr lang="it-IT" sz="1400" b="1" dirty="0" err="1">
                  <a:cs typeface="Arial" panose="020B0604020202020204" pitchFamily="34" charset="0"/>
                </a:rPr>
                <a:t>Neuronal</a:t>
              </a:r>
              <a:r>
                <a:rPr lang="it-IT" sz="1400" b="1" dirty="0">
                  <a:cs typeface="Arial" panose="020B0604020202020204" pitchFamily="34" charset="0"/>
                </a:rPr>
                <a:t> </a:t>
              </a:r>
              <a:r>
                <a:rPr lang="it-IT" sz="1400" b="1" dirty="0" err="1">
                  <a:cs typeface="Arial" panose="020B0604020202020204" pitchFamily="34" charset="0"/>
                </a:rPr>
                <a:t>Synapse</a:t>
              </a:r>
              <a:r>
                <a:rPr lang="it-IT" sz="1400" b="1" dirty="0">
                  <a:cs typeface="Arial" panose="020B0604020202020204" pitchFamily="34" charset="0"/>
                </a:rPr>
                <a:t> </a:t>
              </a:r>
              <a:r>
                <a:rPr lang="it-IT" sz="1400" b="1" dirty="0" err="1">
                  <a:cs typeface="Arial" panose="020B0604020202020204" pitchFamily="34" charset="0"/>
                </a:rPr>
                <a:t>Pathway</a:t>
              </a:r>
              <a:endParaRPr lang="it-IT" sz="1400" b="1" dirty="0"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222057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4115" y="462612"/>
            <a:ext cx="1178662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50402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640" y="414987"/>
            <a:ext cx="1178662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90138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690" y="367362"/>
            <a:ext cx="1178662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38586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165" y="376887"/>
            <a:ext cx="1178662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40790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8507" y="2311448"/>
            <a:ext cx="10509128" cy="24388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22052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3640" y="443562"/>
            <a:ext cx="1178662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66585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649" y="405462"/>
            <a:ext cx="11791651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82423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1062" y="558428"/>
            <a:ext cx="12080938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27556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1062" y="462024"/>
            <a:ext cx="12080938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83303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1062" y="521795"/>
            <a:ext cx="12080938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93987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o 5"/>
          <p:cNvGrpSpPr/>
          <p:nvPr/>
        </p:nvGrpSpPr>
        <p:grpSpPr>
          <a:xfrm>
            <a:off x="106013" y="612225"/>
            <a:ext cx="12000262" cy="5760000"/>
            <a:chOff x="106013" y="612225"/>
            <a:chExt cx="12000262" cy="5760000"/>
          </a:xfrm>
        </p:grpSpPr>
        <p:grpSp>
          <p:nvGrpSpPr>
            <p:cNvPr id="4" name="Gruppo 3"/>
            <p:cNvGrpSpPr/>
            <p:nvPr/>
          </p:nvGrpSpPr>
          <p:grpSpPr>
            <a:xfrm>
              <a:off x="106013" y="612225"/>
              <a:ext cx="12000262" cy="5760000"/>
              <a:chOff x="984114" y="882853"/>
              <a:chExt cx="12000262" cy="5760000"/>
            </a:xfrm>
          </p:grpSpPr>
          <p:pic>
            <p:nvPicPr>
              <p:cNvPr id="2" name="Immagine 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984114" y="882853"/>
                <a:ext cx="7372200" cy="5760000"/>
              </a:xfrm>
              <a:prstGeom prst="rect">
                <a:avLst/>
              </a:prstGeom>
            </p:spPr>
          </p:pic>
          <p:pic>
            <p:nvPicPr>
              <p:cNvPr id="3" name="Immagine 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562054" y="882853"/>
                <a:ext cx="4422322" cy="5760000"/>
              </a:xfrm>
              <a:prstGeom prst="rect">
                <a:avLst/>
              </a:prstGeom>
            </p:spPr>
          </p:pic>
        </p:grpSp>
        <p:sp>
          <p:nvSpPr>
            <p:cNvPr id="5" name="CasellaDiTesto 4"/>
            <p:cNvSpPr txBox="1"/>
            <p:nvPr/>
          </p:nvSpPr>
          <p:spPr>
            <a:xfrm>
              <a:off x="514350" y="612225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A</a:t>
              </a:r>
            </a:p>
          </p:txBody>
        </p:sp>
      </p:grpSp>
      <p:sp>
        <p:nvSpPr>
          <p:cNvPr id="9" name="CasellaDiTesto 8"/>
          <p:cNvSpPr txBox="1"/>
          <p:nvPr/>
        </p:nvSpPr>
        <p:spPr>
          <a:xfrm>
            <a:off x="7886550" y="61222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B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7787715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21256"/>
            <a:ext cx="12192000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34714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88402" y="757123"/>
            <a:ext cx="5815195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08072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/>
          <p:cNvSpPr txBox="1"/>
          <p:nvPr/>
        </p:nvSpPr>
        <p:spPr>
          <a:xfrm>
            <a:off x="0" y="84976"/>
            <a:ext cx="12192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2000" b="1" dirty="0" smtClean="0"/>
              <a:t>SHMO </a:t>
            </a:r>
            <a:r>
              <a:rPr lang="it-IT" sz="2000" b="1" dirty="0" err="1"/>
              <a:t>treatments</a:t>
            </a:r>
            <a:r>
              <a:rPr lang="it-IT" sz="2000" b="1" dirty="0"/>
              <a:t> on </a:t>
            </a:r>
            <a:r>
              <a:rPr lang="it-IT" sz="2000" b="1" dirty="0" err="1"/>
              <a:t>zebrafish</a:t>
            </a:r>
            <a:r>
              <a:rPr lang="it-IT" sz="2000" b="1" dirty="0"/>
              <a:t> </a:t>
            </a:r>
            <a:r>
              <a:rPr lang="it-IT" sz="2000" b="1" dirty="0" err="1" smtClean="0"/>
              <a:t>embryos</a:t>
            </a:r>
            <a:r>
              <a:rPr lang="it-IT" sz="2000" b="1" dirty="0" smtClean="0"/>
              <a:t> – GO </a:t>
            </a:r>
            <a:r>
              <a:rPr lang="it-IT" sz="2000" b="1" dirty="0" err="1" smtClean="0"/>
              <a:t>term</a:t>
            </a:r>
            <a:r>
              <a:rPr lang="it-IT" sz="2000" b="1" dirty="0" smtClean="0"/>
              <a:t> 8</a:t>
            </a:r>
            <a:endParaRPr lang="it-IT" sz="2000" b="1" dirty="0"/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531" y="802855"/>
            <a:ext cx="12080938" cy="57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34271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51</TotalTime>
  <Words>786</Words>
  <Application>Microsoft Office PowerPoint</Application>
  <PresentationFormat>Widescreen</PresentationFormat>
  <Paragraphs>46</Paragraphs>
  <Slides>21</Slides>
  <Notes>2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1</vt:i4>
      </vt:variant>
    </vt:vector>
  </HeadingPairs>
  <TitlesOfParts>
    <vt:vector size="25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aniele Galatolo</dc:creator>
  <cp:lastModifiedBy>Licitra Rosario</cp:lastModifiedBy>
  <cp:revision>95</cp:revision>
  <dcterms:created xsi:type="dcterms:W3CDTF">2022-04-11T00:16:35Z</dcterms:created>
  <dcterms:modified xsi:type="dcterms:W3CDTF">2023-02-10T10:13:19Z</dcterms:modified>
</cp:coreProperties>
</file>